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63" r:id="rId2"/>
  </p:sldIdLst>
  <p:sldSz cx="6858000" cy="12192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>
      <p:cViewPr varScale="1">
        <p:scale>
          <a:sx n="46" d="100"/>
          <a:sy n="46" d="100"/>
        </p:scale>
        <p:origin x="2837" y="4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995312"/>
            <a:ext cx="5829300" cy="4244622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6403623"/>
            <a:ext cx="5143500" cy="2943577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C0AF59-483E-4DCD-8F42-15C46682119F}" type="datetimeFigureOut">
              <a:rPr lang="en-GB" smtClean="0"/>
              <a:t>14/05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8D7309-7FCA-4143-A8BF-5743F7C4781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487641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C0AF59-483E-4DCD-8F42-15C46682119F}" type="datetimeFigureOut">
              <a:rPr lang="en-GB" smtClean="0"/>
              <a:t>14/05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8D7309-7FCA-4143-A8BF-5743F7C4781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8289173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649111"/>
            <a:ext cx="1478756" cy="10332156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649111"/>
            <a:ext cx="4350544" cy="10332156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C0AF59-483E-4DCD-8F42-15C46682119F}" type="datetimeFigureOut">
              <a:rPr lang="en-GB" smtClean="0"/>
              <a:t>14/05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8D7309-7FCA-4143-A8BF-5743F7C4781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5503589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C0AF59-483E-4DCD-8F42-15C46682119F}" type="datetimeFigureOut">
              <a:rPr lang="en-GB" smtClean="0"/>
              <a:t>14/05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8D7309-7FCA-4143-A8BF-5743F7C4781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0437292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3039537"/>
            <a:ext cx="5915025" cy="5071532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8159048"/>
            <a:ext cx="5915025" cy="266699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C0AF59-483E-4DCD-8F42-15C46682119F}" type="datetimeFigureOut">
              <a:rPr lang="en-GB" smtClean="0"/>
              <a:t>14/05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8D7309-7FCA-4143-A8BF-5743F7C4781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2405346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3245556"/>
            <a:ext cx="2914650" cy="773571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3245556"/>
            <a:ext cx="2914650" cy="773571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C0AF59-483E-4DCD-8F42-15C46682119F}" type="datetimeFigureOut">
              <a:rPr lang="en-GB" smtClean="0"/>
              <a:t>14/05/2020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8D7309-7FCA-4143-A8BF-5743F7C4781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0999237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49114"/>
            <a:ext cx="5915025" cy="2356556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988734"/>
            <a:ext cx="2901255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4453467"/>
            <a:ext cx="2901255" cy="6550379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988734"/>
            <a:ext cx="2915543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4453467"/>
            <a:ext cx="2915543" cy="6550379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C0AF59-483E-4DCD-8F42-15C46682119F}" type="datetimeFigureOut">
              <a:rPr lang="en-GB" smtClean="0"/>
              <a:t>14/05/2020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8D7309-7FCA-4143-A8BF-5743F7C4781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1394182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C0AF59-483E-4DCD-8F42-15C46682119F}" type="datetimeFigureOut">
              <a:rPr lang="en-GB" smtClean="0"/>
              <a:t>14/05/2020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8D7309-7FCA-4143-A8BF-5743F7C4781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8946337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C0AF59-483E-4DCD-8F42-15C46682119F}" type="datetimeFigureOut">
              <a:rPr lang="en-GB" smtClean="0"/>
              <a:t>14/05/2020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8D7309-7FCA-4143-A8BF-5743F7C4781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3297703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755425"/>
            <a:ext cx="3471863" cy="8664222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C0AF59-483E-4DCD-8F42-15C46682119F}" type="datetimeFigureOut">
              <a:rPr lang="en-GB" smtClean="0"/>
              <a:t>14/05/2020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8D7309-7FCA-4143-A8BF-5743F7C4781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8785913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755425"/>
            <a:ext cx="3471863" cy="8664222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C0AF59-483E-4DCD-8F42-15C46682119F}" type="datetimeFigureOut">
              <a:rPr lang="en-GB" smtClean="0"/>
              <a:t>14/05/2020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8D7309-7FCA-4143-A8BF-5743F7C4781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8996801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649114"/>
            <a:ext cx="5915025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3245556"/>
            <a:ext cx="5915025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3C0AF59-483E-4DCD-8F42-15C46682119F}" type="datetimeFigureOut">
              <a:rPr lang="en-GB" smtClean="0"/>
              <a:t>14/05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11300181"/>
            <a:ext cx="2314575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08D7309-7FCA-4143-A8BF-5743F7C4781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5716065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E7A73E32-B4DE-4B9E-9C49-9137853CD738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8516" t="23888" r="9255" b="21463"/>
          <a:stretch/>
        </p:blipFill>
        <p:spPr bwMode="auto">
          <a:xfrm>
            <a:off x="-888" y="0"/>
            <a:ext cx="6858888" cy="3418296"/>
          </a:xfrm>
          <a:prstGeom prst="rect">
            <a:avLst/>
          </a:prstGeom>
          <a:noFill/>
          <a:ln>
            <a:noFill/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  <p:sp>
        <p:nvSpPr>
          <p:cNvPr id="5" name="Rectangle 4">
            <a:extLst>
              <a:ext uri="{FF2B5EF4-FFF2-40B4-BE49-F238E27FC236}">
                <a16:creationId xmlns:a16="http://schemas.microsoft.com/office/drawing/2014/main" id="{5E53CEC3-8DEF-4D16-A768-E1F4BCF8D730}"/>
              </a:ext>
            </a:extLst>
          </p:cNvPr>
          <p:cNvSpPr/>
          <p:nvPr/>
        </p:nvSpPr>
        <p:spPr>
          <a:xfrm>
            <a:off x="-888" y="3418296"/>
            <a:ext cx="6858888" cy="120032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spcBef>
                <a:spcPts val="1200"/>
              </a:spcBef>
              <a:spcAft>
                <a:spcPts val="1000"/>
              </a:spcAft>
            </a:pPr>
            <a:r>
              <a:rPr lang="en-GB" sz="1200" b="1" dirty="0">
                <a:latin typeface="Segoe UI" panose="020B0502040204020203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Figure S8.</a:t>
            </a:r>
            <a:r>
              <a:rPr lang="en-GB" sz="1200" dirty="0">
                <a:latin typeface="Segoe UI" panose="020B0502040204020203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Negative controls (mature grain transverse sections of cv Golden Promise) used for immunolabeling of </a:t>
            </a:r>
            <a:r>
              <a:rPr lang="en-GB" sz="1200" dirty="0">
                <a:solidFill>
                  <a:srgbClr val="000000"/>
                </a:solidFill>
                <a:latin typeface="Segoe UI" panose="020B0502040204020203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(1,3;1,4)-β-glucan </a:t>
            </a:r>
            <a:r>
              <a:rPr lang="en-GB" sz="1200" dirty="0">
                <a:latin typeface="Segoe UI" panose="020B0502040204020203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in </a:t>
            </a:r>
            <a:r>
              <a:rPr lang="en-GB" sz="1200" i="1" dirty="0">
                <a:latin typeface="Segoe UI" panose="020B0502040204020203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slf6 </a:t>
            </a:r>
            <a:r>
              <a:rPr lang="en-GB" sz="1200" dirty="0">
                <a:latin typeface="Segoe UI" panose="020B0502040204020203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nd</a:t>
            </a:r>
            <a:r>
              <a:rPr lang="en-GB" sz="1200" i="1" dirty="0">
                <a:latin typeface="Segoe UI" panose="020B0502040204020203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cslf9 </a:t>
            </a:r>
            <a:r>
              <a:rPr lang="en-GB" sz="1200" dirty="0">
                <a:latin typeface="Segoe UI" panose="020B0502040204020203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mutants. Primary antibody is BG-1 (Sigma-Aldrich, St. Louis, USA); secondary antibody is Alexa Fluor 488 (Sigma-Aldrich, St. Louis, USA). No fluorescent labelling was detected for </a:t>
            </a:r>
            <a:r>
              <a:rPr lang="en-GB" sz="1200" dirty="0">
                <a:solidFill>
                  <a:srgbClr val="000000"/>
                </a:solidFill>
                <a:latin typeface="Segoe UI" panose="020B0502040204020203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(1,3;1,4)-β-glucan (green; </a:t>
            </a:r>
            <a:r>
              <a:rPr lang="en-GB" sz="1200" dirty="0">
                <a:latin typeface="Segoe UI" panose="020B0502040204020203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504–543 nm</a:t>
            </a:r>
            <a:r>
              <a:rPr lang="en-GB" sz="1200" dirty="0">
                <a:solidFill>
                  <a:srgbClr val="000000"/>
                </a:solidFill>
                <a:latin typeface="Segoe UI" panose="020B0502040204020203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). Autofluorescence was detected in red (</a:t>
            </a:r>
            <a:r>
              <a:rPr lang="en-GB" sz="1200" dirty="0">
                <a:latin typeface="Segoe UI" panose="020B0502040204020203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631–730 nm)</a:t>
            </a:r>
            <a:r>
              <a:rPr lang="en-GB" sz="1200" dirty="0">
                <a:solidFill>
                  <a:srgbClr val="000000"/>
                </a:solidFill>
                <a:latin typeface="Segoe UI" panose="020B0502040204020203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; Calcofluor counterstaining was detected in blue (</a:t>
            </a:r>
            <a:r>
              <a:rPr lang="en-GB" sz="1200" dirty="0">
                <a:latin typeface="Segoe UI" panose="020B0502040204020203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420–460)</a:t>
            </a:r>
            <a:r>
              <a:rPr lang="en-GB" sz="1200" dirty="0">
                <a:solidFill>
                  <a:srgbClr val="000000"/>
                </a:solidFill>
                <a:latin typeface="Segoe UI" panose="020B0502040204020203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. Scale bars are 1 mm.</a:t>
            </a:r>
            <a:endParaRPr lang="en-GB" sz="1200" dirty="0"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796838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6</TotalTime>
  <Words>97</Words>
  <Application>Microsoft Office PowerPoint</Application>
  <PresentationFormat>Widescreen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Arial</vt:lpstr>
      <vt:lpstr>Calibri</vt:lpstr>
      <vt:lpstr>Calibri Light</vt:lpstr>
      <vt:lpstr>Segoe UI</vt:lpstr>
      <vt:lpstr>Times New Roman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Guillermo Garcia</dc:creator>
  <cp:lastModifiedBy>Guillermo Garcia</cp:lastModifiedBy>
  <cp:revision>9</cp:revision>
  <dcterms:created xsi:type="dcterms:W3CDTF">2020-05-14T00:51:09Z</dcterms:created>
  <dcterms:modified xsi:type="dcterms:W3CDTF">2020-05-14T01:34:32Z</dcterms:modified>
</cp:coreProperties>
</file>